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12193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E52CD-2A05-49F3-8431-E490156BC9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9FD58-C9C5-4887-B4EB-4336F535F9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43144-15E0-4B7D-A9A2-6CA306B88B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AE590-0615-4468-951E-EDBCFBED7F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38"/>
              </a:spcBef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4608B-998C-4196-AE6F-B05DC3C291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879AF-D57D-427B-8A59-191782BC51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96C60-8FCC-43FD-B22B-AF54123C25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48085-4C64-429F-BB5C-0BAAAA3A71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649440"/>
            <a:ext cx="105156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38"/>
              </a:spcBef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BED6BC-B93C-4B1F-ABB9-EB7322ED83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29274-5225-421E-BCB3-ABEBA20C78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DBCD8-B676-47F9-85BC-B202F9D3C2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923B6-8D9B-4339-A462-F46103BFF1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31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1" marL="9129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2" marL="152244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3" marL="21319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4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5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6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11299680"/>
            <a:ext cx="41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17C4F18-3B63-44A1-9507-DBD88C062547}" type="slidenum"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"/>
          <p:cNvSpPr/>
          <p:nvPr/>
        </p:nvSpPr>
        <p:spPr>
          <a:xfrm>
            <a:off x="1928880" y="2173320"/>
            <a:ext cx="937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Supplementary Material 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. Study flowchart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2055960" y="3184560"/>
            <a:ext cx="8080200" cy="5823000"/>
            <a:chOff x="2055960" y="3184560"/>
            <a:chExt cx="8080200" cy="5823000"/>
          </a:xfrm>
        </p:grpSpPr>
        <p:sp>
          <p:nvSpPr>
            <p:cNvPr id="43" name="Text Box 14"/>
            <p:cNvSpPr/>
            <p:nvPr/>
          </p:nvSpPr>
          <p:spPr>
            <a:xfrm>
              <a:off x="4051440" y="4033800"/>
              <a:ext cx="6084720" cy="14270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Excluded: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buClr>
                  <a:srgbClr val="000000"/>
                </a:buClr>
                <a:buFont typeface="Symbol" charset="2"/>
                <a:buChar char=""/>
                <a:tabLst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124,996 participants who died before 2009;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buClr>
                  <a:srgbClr val="000000"/>
                </a:buClr>
                <a:buFont typeface="Symbol" charset="2"/>
                <a:buChar char=""/>
                <a:tabLst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3,027,390 participants who did not participate in the 2009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−2010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general health examination, as information on smoking duration has only been collected since then.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 Box 2"/>
            <p:cNvSpPr/>
            <p:nvPr/>
          </p:nvSpPr>
          <p:spPr>
            <a:xfrm>
              <a:off x="2055960" y="3184560"/>
              <a:ext cx="8066880" cy="6588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The National Health Insurance Service (NHIS) customized database of cancer-free participants in the 2006−2007 general health examination (n = 13,034,526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5" name="Straight Arrow Connector 6"/>
            <p:cNvCxnSpPr/>
            <p:nvPr/>
          </p:nvCxnSpPr>
          <p:spPr>
            <a:xfrm>
              <a:off x="3301200" y="3840120"/>
              <a:ext cx="1080" cy="180036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6" name="Text Box 17"/>
            <p:cNvSpPr/>
            <p:nvPr/>
          </p:nvSpPr>
          <p:spPr>
            <a:xfrm>
              <a:off x="2055960" y="5654160"/>
              <a:ext cx="8071200" cy="4089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Participants who attended the 2009−2010 general health examination (n = 9,882,140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 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7" name="Straight Arrow Connector 8"/>
            <p:cNvCxnSpPr/>
            <p:nvPr/>
          </p:nvCxnSpPr>
          <p:spPr>
            <a:xfrm>
              <a:off x="3297960" y="6065640"/>
              <a:ext cx="1080" cy="57312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8" name="Straight Arrow Connector 9"/>
            <p:cNvCxnSpPr/>
            <p:nvPr/>
          </p:nvCxnSpPr>
          <p:spPr>
            <a:xfrm>
              <a:off x="3313800" y="4759560"/>
              <a:ext cx="72072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9" name="Text Box 5"/>
            <p:cNvSpPr/>
            <p:nvPr/>
          </p:nvSpPr>
          <p:spPr>
            <a:xfrm>
              <a:off x="2055960" y="6644520"/>
              <a:ext cx="8066160" cy="4089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Patients who were diagnosed with lung cancer between 2009 and 2022 (n = 92,145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0" name="Straight Arrow Connector 11"/>
            <p:cNvCxnSpPr/>
            <p:nvPr/>
          </p:nvCxnSpPr>
          <p:spPr>
            <a:xfrm>
              <a:off x="3297960" y="7068600"/>
              <a:ext cx="1080" cy="15274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1" name="Straight Arrow Connector 12"/>
            <p:cNvCxnSpPr/>
            <p:nvPr/>
          </p:nvCxnSpPr>
          <p:spPr>
            <a:xfrm>
              <a:off x="3293640" y="7812360"/>
              <a:ext cx="72072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2" name="Text Box 5"/>
            <p:cNvSpPr/>
            <p:nvPr/>
          </p:nvSpPr>
          <p:spPr>
            <a:xfrm>
              <a:off x="2068920" y="8599680"/>
              <a:ext cx="8065080" cy="4078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Study sample (n = 81,438, including 56,932 men and 24,506 women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 Box 14"/>
            <p:cNvSpPr/>
            <p:nvPr/>
          </p:nvSpPr>
          <p:spPr>
            <a:xfrm>
              <a:off x="4041720" y="7261200"/>
              <a:ext cx="6084720" cy="11318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Excluded: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buClr>
                  <a:srgbClr val="000000"/>
                </a:buClr>
                <a:buFont typeface="Symbol" charset="2"/>
                <a:buChar char=""/>
                <a:tabLst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10,350 participants who were diagnosed within 2009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−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2010;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buClr>
                  <a:srgbClr val="000000"/>
                </a:buClr>
                <a:buFont typeface="Symbol" charset="2"/>
                <a:buChar char=""/>
                <a:tabLst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바탕"/>
                </a:rPr>
                <a:t>357 participants with missing information on age, gender, or smoking status.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1-08T14:40:59Z</dcterms:created>
  <dc:creator>JE editorial office</dc:creator>
  <dc:description/>
  <dc:language>en-US</dc:language>
  <cp:lastModifiedBy>이제인</cp:lastModifiedBy>
  <dcterms:modified xsi:type="dcterms:W3CDTF">2026-05-28T04:14:05Z</dcterms:modified>
  <cp:revision>4</cp:revision>
  <dc:subject/>
  <dc:title>PowerPoint プレゼンテーション</dc:title>
</cp:coreProperties>
</file>